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D1EAD10-4D22-4412-A1B3-3860A9C20132}" v="1" dt="2022-12-19T01:59:12.84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807"/>
  </p:normalViewPr>
  <p:slideViewPr>
    <p:cSldViewPr snapToGrid="0">
      <p:cViewPr>
        <p:scale>
          <a:sx n="100" d="100"/>
          <a:sy n="100" d="100"/>
        </p:scale>
        <p:origin x="2550" y="-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8864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16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425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02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585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017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245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2772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053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613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937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DA0A6-810B-A146-9018-9F53B068B67D}" type="datetimeFigureOut">
              <a:rPr lang="en-US" smtClean="0"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51D97E-BF1F-FE4E-9AD5-339DD0E292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57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6037949A-688C-8EE3-4ADF-F5C3C786ED85}"/>
              </a:ext>
            </a:extLst>
          </p:cNvPr>
          <p:cNvGrpSpPr/>
          <p:nvPr/>
        </p:nvGrpSpPr>
        <p:grpSpPr>
          <a:xfrm>
            <a:off x="1323975" y="1076028"/>
            <a:ext cx="3917496" cy="3142924"/>
            <a:chOff x="1895475" y="1874838"/>
            <a:chExt cx="2455863" cy="2145023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DE070A26-0C37-F343-351B-332A174759C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97620104"/>
                </p:ext>
              </p:extLst>
            </p:nvPr>
          </p:nvGraphicFramePr>
          <p:xfrm>
            <a:off x="1895475" y="1874838"/>
            <a:ext cx="2455863" cy="19383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3530771" imgH="2780284" progId="Prism9.Document">
                    <p:embed/>
                  </p:oleObj>
                </mc:Choice>
                <mc:Fallback>
                  <p:oleObj name="Prism 9" r:id="rId2" imgW="3530771" imgH="2780284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DE070A26-0C37-F343-351B-332A174759C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895475" y="1874838"/>
                          <a:ext cx="2455863" cy="19383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D44FD73-409E-5E92-6B44-516D5722CAD8}"/>
                </a:ext>
              </a:extLst>
            </p:cNvPr>
            <p:cNvSpPr txBox="1"/>
            <p:nvPr/>
          </p:nvSpPr>
          <p:spPr>
            <a:xfrm>
              <a:off x="2350786" y="3716298"/>
              <a:ext cx="714147" cy="294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100" dirty="0">
                  <a:latin typeface="Arial" panose="020B0604020202020204" pitchFamily="34" charset="0"/>
                  <a:cs typeface="Arial" panose="020B0604020202020204" pitchFamily="34" charset="0"/>
                </a:rPr>
                <a:t>Methylated</a:t>
              </a:r>
            </a:p>
            <a:p>
              <a:pPr algn="ctr"/>
              <a:r>
                <a:rPr lang="en-AU" sz="1100" dirty="0">
                  <a:latin typeface="Arial" panose="020B0604020202020204" pitchFamily="34" charset="0"/>
                  <a:cs typeface="Arial" panose="020B0604020202020204" pitchFamily="34" charset="0"/>
                </a:rPr>
                <a:t>MGMT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EBD5304-4DC6-1F65-3583-EFA0BD34327D}"/>
                </a:ext>
              </a:extLst>
            </p:cNvPr>
            <p:cNvSpPr txBox="1"/>
            <p:nvPr/>
          </p:nvSpPr>
          <p:spPr>
            <a:xfrm>
              <a:off x="3265997" y="3725784"/>
              <a:ext cx="889351" cy="2940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>
                  <a:latin typeface="Arial" panose="020B0604020202020204" pitchFamily="34" charset="0"/>
                  <a:cs typeface="Arial" panose="020B0604020202020204" pitchFamily="34" charset="0"/>
                </a:rPr>
                <a:t>Unmethylated</a:t>
              </a:r>
            </a:p>
            <a:p>
              <a:pPr algn="ctr"/>
              <a:r>
                <a:rPr lang="en-AU" sz="1100" dirty="0">
                  <a:latin typeface="Arial" panose="020B0604020202020204" pitchFamily="34" charset="0"/>
                  <a:cs typeface="Arial" panose="020B0604020202020204" pitchFamily="34" charset="0"/>
                </a:rPr>
                <a:t>MGMT</a:t>
              </a:r>
            </a:p>
          </p:txBody>
        </p: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A45DCC53-4F92-7C53-74C7-97A8DA6926A6}"/>
                </a:ext>
              </a:extLst>
            </p:cNvPr>
            <p:cNvCxnSpPr/>
            <p:nvPr/>
          </p:nvCxnSpPr>
          <p:spPr>
            <a:xfrm>
              <a:off x="2230969" y="3730968"/>
              <a:ext cx="94862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id="{B79DEC95-62CF-3FB3-B524-A00C95B7EB89}"/>
                </a:ext>
              </a:extLst>
            </p:cNvPr>
            <p:cNvCxnSpPr/>
            <p:nvPr/>
          </p:nvCxnSpPr>
          <p:spPr>
            <a:xfrm>
              <a:off x="3263131" y="3731780"/>
              <a:ext cx="94862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46929FD-9CD5-BE15-2A81-541A6D8339BD}"/>
              </a:ext>
            </a:extLst>
          </p:cNvPr>
          <p:cNvSpPr txBox="1"/>
          <p:nvPr/>
        </p:nvSpPr>
        <p:spPr>
          <a:xfrm>
            <a:off x="554084" y="4306669"/>
            <a:ext cx="574983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AU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percentage of invading cells is shown in a panel of GBM cells treated with anti-proNGF (600ng/ml) for 48 hours compared to untreated cells. The results are presented as % of invading cells with 100% the value observed in the untreated condition. Data shown are the mean </a:t>
            </a:r>
            <a:r>
              <a:rPr lang="en-AU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</a:t>
            </a:r>
            <a:r>
              <a:rPr lang="en-AU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SD of three independent experiments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0109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0B6C767-33DF-FF61-F14D-BE3CC922264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99959" y="1232822"/>
            <a:ext cx="2082800" cy="32639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2AD5D95-A685-098E-205C-5BC02885CCB3}"/>
              </a:ext>
            </a:extLst>
          </p:cNvPr>
          <p:cNvSpPr txBox="1"/>
          <p:nvPr/>
        </p:nvSpPr>
        <p:spPr>
          <a:xfrm>
            <a:off x="273224" y="4680573"/>
            <a:ext cx="631155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AU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iability was detected in a panel of GBM cells treated antibody against </a:t>
            </a:r>
            <a:r>
              <a:rPr lang="en-AU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NGF</a:t>
            </a:r>
            <a:r>
              <a:rPr lang="en-AU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(anti-</a:t>
            </a:r>
            <a:r>
              <a:rPr lang="en-AU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proNGF</a:t>
            </a:r>
            <a:r>
              <a:rPr lang="en-AU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600ng/ml) for 72 hours. (B) Comparison the difference </a:t>
            </a:r>
            <a:r>
              <a:rPr lang="en-AU" sz="1200" dirty="0">
                <a:latin typeface="Arial" panose="020B0604020202020204" pitchFamily="34" charset="0"/>
                <a:ea typeface="Times New Roman" panose="02020603050405020304" pitchFamily="18" charset="0"/>
              </a:rPr>
              <a:t>of cell </a:t>
            </a:r>
            <a:r>
              <a:rPr lang="en-AU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viability </a:t>
            </a:r>
            <a:r>
              <a:rPr lang="en-AU" sz="1200" dirty="0">
                <a:latin typeface="Arial" panose="020B0604020202020204" pitchFamily="34" charset="0"/>
                <a:ea typeface="Times New Roman" panose="02020603050405020304" pitchFamily="18" charset="0"/>
              </a:rPr>
              <a:t>between methylated </a:t>
            </a:r>
            <a:r>
              <a:rPr lang="en-AU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GMT GBM cell lines and unmethylated MGMT GBM cell lines. </a:t>
            </a:r>
            <a:r>
              <a:rPr lang="en-AU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ata shown are the mean </a:t>
            </a:r>
            <a:r>
              <a:rPr lang="en-AU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  <a:sym typeface="Symbol" pitchFamily="2" charset="2"/>
              </a:rPr>
              <a:t></a:t>
            </a:r>
            <a:r>
              <a:rPr lang="en-AU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D of three independent experiments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F045EE5-C973-F0C0-CCA6-06932D2B5D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1525" y="1232822"/>
            <a:ext cx="3467100" cy="31242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8EE63F9-6D88-3DB3-0182-3388E33C6290}"/>
              </a:ext>
            </a:extLst>
          </p:cNvPr>
          <p:cNvSpPr txBox="1"/>
          <p:nvPr/>
        </p:nvSpPr>
        <p:spPr>
          <a:xfrm>
            <a:off x="121525" y="10122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2AA116A-3247-9F3C-6232-4CE824E0A7F2}"/>
              </a:ext>
            </a:extLst>
          </p:cNvPr>
          <p:cNvSpPr txBox="1"/>
          <p:nvPr/>
        </p:nvSpPr>
        <p:spPr>
          <a:xfrm>
            <a:off x="4052322" y="104919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249673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</TotalTime>
  <Words>137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 Chen Jiang</dc:creator>
  <cp:lastModifiedBy>MDPI</cp:lastModifiedBy>
  <cp:revision>11</cp:revision>
  <dcterms:created xsi:type="dcterms:W3CDTF">2022-10-21T00:40:49Z</dcterms:created>
  <dcterms:modified xsi:type="dcterms:W3CDTF">2023-01-13T09:10:25Z</dcterms:modified>
</cp:coreProperties>
</file>